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757872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2040" y="-96"/>
      </p:cViewPr>
      <p:guideLst>
        <p:guide orient="horz" pos="238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354317"/>
            <a:ext cx="7772400" cy="162451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294611"/>
            <a:ext cx="6400800" cy="193678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5793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769780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35079"/>
            <a:ext cx="2057400" cy="714715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35079"/>
            <a:ext cx="6019800" cy="714715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58116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06331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870033"/>
            <a:ext cx="7772400" cy="150521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212187"/>
            <a:ext cx="7772400" cy="165784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79091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54329"/>
            <a:ext cx="4038600" cy="552790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54329"/>
            <a:ext cx="4038600" cy="552790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32761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03500"/>
            <a:ext cx="8229600" cy="1263121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96442"/>
            <a:ext cx="4040188" cy="70699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403438"/>
            <a:ext cx="4040188" cy="436653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696442"/>
            <a:ext cx="4041775" cy="70699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403438"/>
            <a:ext cx="4041775" cy="436653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46750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5735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12785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301745"/>
            <a:ext cx="3008313" cy="128417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01746"/>
            <a:ext cx="5111750" cy="646823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585919"/>
            <a:ext cx="3008313" cy="518405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29846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5305107"/>
            <a:ext cx="5486400" cy="62629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77173"/>
            <a:ext cx="5486400" cy="454723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931405"/>
            <a:ext cx="5486400" cy="8894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03273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03500"/>
            <a:ext cx="8229600" cy="12631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768370"/>
            <a:ext cx="8229600" cy="500160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7024356"/>
            <a:ext cx="2133600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9BE58A-455D-469E-85C0-0094D3852341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7024356"/>
            <a:ext cx="2895600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7024356"/>
            <a:ext cx="2133600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A3F54-E7DE-4C65-B63C-13BDEF78EEB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1093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/>
          <p:cNvSpPr txBox="1"/>
          <p:nvPr/>
        </p:nvSpPr>
        <p:spPr>
          <a:xfrm>
            <a:off x="3725752" y="103014"/>
            <a:ext cx="88517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200" dirty="0" smtClean="0"/>
              <a:t>T cells</a:t>
            </a:r>
            <a:endParaRPr lang="de-DE" sz="2200" dirty="0"/>
          </a:p>
        </p:txBody>
      </p:sp>
      <p:sp>
        <p:nvSpPr>
          <p:cNvPr id="50" name="Rectangle 49"/>
          <p:cNvSpPr/>
          <p:nvPr/>
        </p:nvSpPr>
        <p:spPr>
          <a:xfrm>
            <a:off x="6883678" y="2895601"/>
            <a:ext cx="1574522" cy="1767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1" name="Rectangle 50"/>
          <p:cNvSpPr/>
          <p:nvPr/>
        </p:nvSpPr>
        <p:spPr>
          <a:xfrm rot="16200000">
            <a:off x="-433514" y="1859021"/>
            <a:ext cx="1927107" cy="904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2" name="Rectangle 51"/>
          <p:cNvSpPr/>
          <p:nvPr/>
        </p:nvSpPr>
        <p:spPr>
          <a:xfrm rot="16200000">
            <a:off x="3725617" y="1832142"/>
            <a:ext cx="1947567" cy="1237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3" name="Rectangle 52"/>
          <p:cNvSpPr/>
          <p:nvPr/>
        </p:nvSpPr>
        <p:spPr>
          <a:xfrm rot="16200000">
            <a:off x="1738150" y="1833301"/>
            <a:ext cx="1826145" cy="904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4" name="Rectangle 53"/>
          <p:cNvSpPr/>
          <p:nvPr/>
        </p:nvSpPr>
        <p:spPr>
          <a:xfrm>
            <a:off x="1086754" y="2959041"/>
            <a:ext cx="970646" cy="904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5" name="Rectangle 54"/>
          <p:cNvSpPr/>
          <p:nvPr/>
        </p:nvSpPr>
        <p:spPr>
          <a:xfrm rot="16200000">
            <a:off x="3766049" y="4142318"/>
            <a:ext cx="1797555" cy="1928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6" name="Rectangle 55"/>
          <p:cNvSpPr/>
          <p:nvPr/>
        </p:nvSpPr>
        <p:spPr>
          <a:xfrm rot="16200000">
            <a:off x="6037960" y="4285359"/>
            <a:ext cx="1762671" cy="1822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57" name="Group 56"/>
          <p:cNvGrpSpPr/>
          <p:nvPr/>
        </p:nvGrpSpPr>
        <p:grpSpPr>
          <a:xfrm>
            <a:off x="228600" y="454095"/>
            <a:ext cx="8301961" cy="6406190"/>
            <a:chOff x="136583" y="164569"/>
            <a:chExt cx="8774978" cy="6631685"/>
          </a:xfrm>
        </p:grpSpPr>
        <p:grpSp>
          <p:nvGrpSpPr>
            <p:cNvPr id="58" name="Group 57"/>
            <p:cNvGrpSpPr/>
            <p:nvPr/>
          </p:nvGrpSpPr>
          <p:grpSpPr>
            <a:xfrm>
              <a:off x="6903552" y="320634"/>
              <a:ext cx="2008009" cy="2176772"/>
              <a:chOff x="4950023" y="989003"/>
              <a:chExt cx="2145109" cy="2269814"/>
            </a:xfrm>
          </p:grpSpPr>
          <p:pic>
            <p:nvPicPr>
              <p:cNvPr id="89" name="Picture 4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181600" y="989003"/>
                <a:ext cx="1913532" cy="201020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0" name="TextBox 89"/>
              <p:cNvSpPr txBox="1"/>
              <p:nvPr/>
            </p:nvSpPr>
            <p:spPr>
              <a:xfrm>
                <a:off x="5835385" y="2951040"/>
                <a:ext cx="776175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D45RA</a:t>
                </a:r>
                <a:endParaRPr lang="de-DE" sz="1400" dirty="0"/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 rot="16200000">
                <a:off x="4820821" y="1849021"/>
                <a:ext cx="5661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CR7</a:t>
                </a:r>
                <a:endParaRPr lang="de-DE" sz="1400" dirty="0"/>
              </a:p>
            </p:txBody>
          </p:sp>
        </p:grpSp>
        <p:grpSp>
          <p:nvGrpSpPr>
            <p:cNvPr id="59" name="Group 58"/>
            <p:cNvGrpSpPr/>
            <p:nvPr/>
          </p:nvGrpSpPr>
          <p:grpSpPr>
            <a:xfrm>
              <a:off x="136583" y="2350935"/>
              <a:ext cx="2239696" cy="2069269"/>
              <a:chOff x="2271672" y="3484062"/>
              <a:chExt cx="2392614" cy="2157716"/>
            </a:xfrm>
          </p:grpSpPr>
          <p:pic>
            <p:nvPicPr>
              <p:cNvPr id="86" name="Picture 6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39752" y="3484062"/>
                <a:ext cx="2324534" cy="194550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7" name="TextBox 86"/>
              <p:cNvSpPr txBox="1"/>
              <p:nvPr/>
            </p:nvSpPr>
            <p:spPr>
              <a:xfrm rot="16200000">
                <a:off x="2138463" y="4283414"/>
                <a:ext cx="5741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D28</a:t>
                </a:r>
                <a:endParaRPr lang="de-DE" sz="1400" dirty="0"/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2655650" y="5334001"/>
                <a:ext cx="172803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 smtClean="0"/>
                  <a:t>               CD27</a:t>
                </a:r>
                <a:endParaRPr lang="de-DE" sz="1400" dirty="0"/>
              </a:p>
            </p:txBody>
          </p:sp>
        </p:grpSp>
        <p:grpSp>
          <p:nvGrpSpPr>
            <p:cNvPr id="60" name="Group 59"/>
            <p:cNvGrpSpPr/>
            <p:nvPr/>
          </p:nvGrpSpPr>
          <p:grpSpPr>
            <a:xfrm>
              <a:off x="956842" y="4638223"/>
              <a:ext cx="2121599" cy="2158031"/>
              <a:chOff x="6547649" y="3449692"/>
              <a:chExt cx="2266454" cy="2250272"/>
            </a:xfrm>
          </p:grpSpPr>
          <p:pic>
            <p:nvPicPr>
              <p:cNvPr id="83" name="Picture 8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01250" y="3449692"/>
                <a:ext cx="2012853" cy="20806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4" name="TextBox 83"/>
              <p:cNvSpPr txBox="1"/>
              <p:nvPr/>
            </p:nvSpPr>
            <p:spPr>
              <a:xfrm>
                <a:off x="7454429" y="5392187"/>
                <a:ext cx="7761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D45RA</a:t>
                </a:r>
                <a:endParaRPr lang="de-DE" sz="1400" dirty="0"/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 rot="16200000">
                <a:off x="6418447" y="4328027"/>
                <a:ext cx="5661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CR7</a:t>
                </a:r>
                <a:endParaRPr lang="de-DE" sz="1400" dirty="0"/>
              </a:p>
            </p:txBody>
          </p:sp>
        </p:grpSp>
        <p:grpSp>
          <p:nvGrpSpPr>
            <p:cNvPr id="61" name="Group 60"/>
            <p:cNvGrpSpPr/>
            <p:nvPr/>
          </p:nvGrpSpPr>
          <p:grpSpPr>
            <a:xfrm>
              <a:off x="2741168" y="2584101"/>
              <a:ext cx="2071352" cy="2166195"/>
              <a:chOff x="4329678" y="3449693"/>
              <a:chExt cx="2212777" cy="2258785"/>
            </a:xfrm>
          </p:grpSpPr>
          <p:pic>
            <p:nvPicPr>
              <p:cNvPr id="80" name="Picture 7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29038" y="3449693"/>
                <a:ext cx="1913417" cy="208280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1" name="TextBox 80"/>
              <p:cNvSpPr txBox="1"/>
              <p:nvPr/>
            </p:nvSpPr>
            <p:spPr>
              <a:xfrm>
                <a:off x="5103340" y="5400701"/>
                <a:ext cx="7761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D45RA</a:t>
                </a:r>
                <a:endParaRPr lang="de-DE" sz="1400" dirty="0"/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 rot="16200000">
                <a:off x="4200476" y="4226816"/>
                <a:ext cx="5661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CR7</a:t>
                </a:r>
                <a:endParaRPr lang="de-DE" sz="1400" dirty="0"/>
              </a:p>
            </p:txBody>
          </p:sp>
        </p:grpSp>
        <p:grpSp>
          <p:nvGrpSpPr>
            <p:cNvPr id="62" name="Group 61"/>
            <p:cNvGrpSpPr/>
            <p:nvPr/>
          </p:nvGrpSpPr>
          <p:grpSpPr>
            <a:xfrm>
              <a:off x="4709314" y="390064"/>
              <a:ext cx="2096605" cy="2288095"/>
              <a:chOff x="2725509" y="840322"/>
              <a:chExt cx="2239754" cy="2385895"/>
            </a:xfrm>
          </p:grpSpPr>
          <p:pic>
            <p:nvPicPr>
              <p:cNvPr id="77" name="Picture 3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33824" y="840322"/>
                <a:ext cx="2031439" cy="20274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78" name="TextBox 77"/>
              <p:cNvSpPr txBox="1"/>
              <p:nvPr/>
            </p:nvSpPr>
            <p:spPr>
              <a:xfrm>
                <a:off x="3716097" y="2918440"/>
                <a:ext cx="57419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D27</a:t>
                </a:r>
                <a:endParaRPr lang="de-DE" sz="1400" dirty="0"/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 rot="16200000">
                <a:off x="2592300" y="1644890"/>
                <a:ext cx="5741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D28</a:t>
                </a:r>
                <a:endParaRPr lang="de-DE" sz="1400" dirty="0"/>
              </a:p>
            </p:txBody>
          </p:sp>
        </p:grpSp>
        <p:grpSp>
          <p:nvGrpSpPr>
            <p:cNvPr id="63" name="Group 62"/>
            <p:cNvGrpSpPr/>
            <p:nvPr/>
          </p:nvGrpSpPr>
          <p:grpSpPr>
            <a:xfrm>
              <a:off x="6944143" y="2669742"/>
              <a:ext cx="1926828" cy="2157387"/>
              <a:chOff x="7083622" y="1042240"/>
              <a:chExt cx="2058385" cy="2249600"/>
            </a:xfrm>
          </p:grpSpPr>
          <p:pic>
            <p:nvPicPr>
              <p:cNvPr id="74" name="Picture 5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239000" y="1042240"/>
                <a:ext cx="1903007" cy="199718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75" name="TextBox 74"/>
              <p:cNvSpPr txBox="1"/>
              <p:nvPr/>
            </p:nvSpPr>
            <p:spPr>
              <a:xfrm rot="16200000">
                <a:off x="6413212" y="1813410"/>
                <a:ext cx="164859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/>
                  <a:t> </a:t>
                </a:r>
                <a:r>
                  <a:rPr lang="de-DE" sz="1400" dirty="0" smtClean="0"/>
                  <a:t>            CCR7</a:t>
                </a:r>
                <a:endParaRPr lang="de-DE" sz="1400" dirty="0"/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7834425" y="2984063"/>
                <a:ext cx="776175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D45RA</a:t>
                </a:r>
                <a:endParaRPr lang="de-DE" sz="1400" dirty="0"/>
              </a:p>
            </p:txBody>
          </p:sp>
        </p:grpSp>
        <p:grpSp>
          <p:nvGrpSpPr>
            <p:cNvPr id="64" name="Group 63"/>
            <p:cNvGrpSpPr/>
            <p:nvPr/>
          </p:nvGrpSpPr>
          <p:grpSpPr>
            <a:xfrm>
              <a:off x="1330624" y="164569"/>
              <a:ext cx="2239650" cy="2112666"/>
              <a:chOff x="-27266" y="805961"/>
              <a:chExt cx="2392565" cy="2202968"/>
            </a:xfrm>
          </p:grpSpPr>
          <p:pic>
            <p:nvPicPr>
              <p:cNvPr id="71" name="Picture 2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7680" y="805961"/>
                <a:ext cx="1937619" cy="1985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72" name="TextBox 71"/>
              <p:cNvSpPr txBox="1"/>
              <p:nvPr/>
            </p:nvSpPr>
            <p:spPr>
              <a:xfrm>
                <a:off x="-27266" y="1208678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D8</a:t>
                </a:r>
                <a:endParaRPr lang="de-DE" sz="1400" dirty="0"/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1106308" y="2701152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CD4</a:t>
                </a:r>
                <a:endParaRPr lang="de-DE" sz="1400" dirty="0"/>
              </a:p>
            </p:txBody>
          </p:sp>
        </p:grpSp>
        <p:cxnSp>
          <p:nvCxnSpPr>
            <p:cNvPr id="65" name="Straight Arrow Connector 64"/>
            <p:cNvCxnSpPr/>
            <p:nvPr/>
          </p:nvCxnSpPr>
          <p:spPr>
            <a:xfrm flipV="1">
              <a:off x="3358247" y="1362249"/>
              <a:ext cx="1061352" cy="844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Arrow Connector 65"/>
            <p:cNvCxnSpPr/>
            <p:nvPr/>
          </p:nvCxnSpPr>
          <p:spPr>
            <a:xfrm flipH="1">
              <a:off x="1104642" y="891179"/>
              <a:ext cx="803856" cy="122363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Arrow Connector 66"/>
            <p:cNvCxnSpPr/>
            <p:nvPr/>
          </p:nvCxnSpPr>
          <p:spPr>
            <a:xfrm>
              <a:off x="6805919" y="1904244"/>
              <a:ext cx="31440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Arrow Connector 67"/>
            <p:cNvCxnSpPr/>
            <p:nvPr/>
          </p:nvCxnSpPr>
          <p:spPr>
            <a:xfrm>
              <a:off x="6919295" y="2248436"/>
              <a:ext cx="201033" cy="24897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Arrow Connector 68"/>
            <p:cNvCxnSpPr/>
            <p:nvPr/>
          </p:nvCxnSpPr>
          <p:spPr>
            <a:xfrm>
              <a:off x="2402109" y="3962400"/>
              <a:ext cx="48311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Arrow Connector 69"/>
            <p:cNvCxnSpPr/>
            <p:nvPr/>
          </p:nvCxnSpPr>
          <p:spPr>
            <a:xfrm>
              <a:off x="2209800" y="4125043"/>
              <a:ext cx="0" cy="33009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2" name="TextBox 91"/>
          <p:cNvSpPr txBox="1"/>
          <p:nvPr/>
        </p:nvSpPr>
        <p:spPr>
          <a:xfrm>
            <a:off x="3511951" y="15977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CD4</a:t>
            </a:r>
            <a:endParaRPr lang="de-DE" sz="1200" dirty="0"/>
          </a:p>
        </p:txBody>
      </p:sp>
      <p:sp>
        <p:nvSpPr>
          <p:cNvPr id="93" name="TextBox 92"/>
          <p:cNvSpPr txBox="1"/>
          <p:nvPr/>
        </p:nvSpPr>
        <p:spPr>
          <a:xfrm rot="-3480000">
            <a:off x="1160418" y="1636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CD8</a:t>
            </a:r>
            <a:endParaRPr lang="de-DE" sz="1200" dirty="0"/>
          </a:p>
        </p:txBody>
      </p:sp>
      <p:sp>
        <p:nvSpPr>
          <p:cNvPr id="94" name="TextBox 93"/>
          <p:cNvSpPr txBox="1"/>
          <p:nvPr/>
        </p:nvSpPr>
        <p:spPr>
          <a:xfrm>
            <a:off x="1331640" y="7101730"/>
            <a:ext cx="7776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Additional File 2. Gating strategy used to identify T cell subsets and </a:t>
            </a:r>
            <a:r>
              <a:rPr lang="de-DE" sz="1200" smtClean="0"/>
              <a:t>differentiation </a:t>
            </a:r>
            <a:r>
              <a:rPr lang="de-DE" sz="1200" smtClean="0"/>
              <a:t>stages. </a:t>
            </a: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578832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6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Shipp</dc:creator>
  <cp:lastModifiedBy>Christopher Shipp</cp:lastModifiedBy>
  <cp:revision>6</cp:revision>
  <dcterms:created xsi:type="dcterms:W3CDTF">2016-09-26T10:40:49Z</dcterms:created>
  <dcterms:modified xsi:type="dcterms:W3CDTF">2017-01-21T15:25:39Z</dcterms:modified>
</cp:coreProperties>
</file>